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9" r:id="rId5"/>
    <p:sldId id="256" r:id="rId6"/>
    <p:sldId id="257" r:id="rId7"/>
    <p:sldId id="258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4" d="100"/>
          <a:sy n="84" d="100"/>
        </p:scale>
        <p:origin x="36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18EB4-B706-47AF-87BE-02DEB2DB660A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514F0-F8E7-4E29-8766-B0FA721F7B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3450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18EB4-B706-47AF-87BE-02DEB2DB660A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514F0-F8E7-4E29-8766-B0FA721F7B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7071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18EB4-B706-47AF-87BE-02DEB2DB660A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514F0-F8E7-4E29-8766-B0FA721F7B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6203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18EB4-B706-47AF-87BE-02DEB2DB660A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514F0-F8E7-4E29-8766-B0FA721F7B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75134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18EB4-B706-47AF-87BE-02DEB2DB660A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514F0-F8E7-4E29-8766-B0FA721F7B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41825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18EB4-B706-47AF-87BE-02DEB2DB660A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514F0-F8E7-4E29-8766-B0FA721F7B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62754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18EB4-B706-47AF-87BE-02DEB2DB660A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514F0-F8E7-4E29-8766-B0FA721F7B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6568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18EB4-B706-47AF-87BE-02DEB2DB660A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514F0-F8E7-4E29-8766-B0FA721F7B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2916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18EB4-B706-47AF-87BE-02DEB2DB660A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514F0-F8E7-4E29-8766-B0FA721F7B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631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18EB4-B706-47AF-87BE-02DEB2DB660A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514F0-F8E7-4E29-8766-B0FA721F7B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7834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18EB4-B706-47AF-87BE-02DEB2DB660A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514F0-F8E7-4E29-8766-B0FA721F7B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90767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318EB4-B706-47AF-87BE-02DEB2DB660A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7514F0-F8E7-4E29-8766-B0FA721F7B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0220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16667" t="6745" r="22012" b="31469"/>
          <a:stretch/>
        </p:blipFill>
        <p:spPr>
          <a:xfrm>
            <a:off x="8208691" y="1873406"/>
            <a:ext cx="3958683" cy="281010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l="19798" t="26223" r="16001" b="17688"/>
          <a:stretch/>
        </p:blipFill>
        <p:spPr>
          <a:xfrm>
            <a:off x="3944200" y="1873405"/>
            <a:ext cx="4052525" cy="281010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/>
          <a:srcRect l="20827" t="21543" r="21529" b="21556"/>
          <a:stretch/>
        </p:blipFill>
        <p:spPr>
          <a:xfrm>
            <a:off x="12266" y="1895707"/>
            <a:ext cx="3749040" cy="278780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03615" y="1490811"/>
            <a:ext cx="27989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Transferrin </a:t>
            </a:r>
            <a:r>
              <a:rPr lang="en-US" b="1" dirty="0" smtClean="0"/>
              <a:t>receptor (TFRC)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4657056" y="1490811"/>
            <a:ext cx="27989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H-ferritin (FTH1)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8638352" y="1508938"/>
            <a:ext cx="27989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GAPDH</a:t>
            </a:r>
            <a:endParaRPr lang="en-US" b="1" dirty="0"/>
          </a:p>
        </p:txBody>
      </p:sp>
      <p:grpSp>
        <p:nvGrpSpPr>
          <p:cNvPr id="8" name="Group 7"/>
          <p:cNvGrpSpPr/>
          <p:nvPr/>
        </p:nvGrpSpPr>
        <p:grpSpPr>
          <a:xfrm>
            <a:off x="503615" y="2593467"/>
            <a:ext cx="2725014" cy="469267"/>
            <a:chOff x="847234" y="2315523"/>
            <a:chExt cx="2725014" cy="469267"/>
          </a:xfrm>
        </p:grpSpPr>
        <p:sp>
          <p:nvSpPr>
            <p:cNvPr id="9" name="TextBox 8"/>
            <p:cNvSpPr txBox="1"/>
            <p:nvPr/>
          </p:nvSpPr>
          <p:spPr>
            <a:xfrm>
              <a:off x="2795855" y="2323125"/>
              <a:ext cx="7763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WT </a:t>
              </a:r>
            </a:p>
            <a:p>
              <a:pPr algn="ctr"/>
              <a:r>
                <a:rPr lang="en-US" sz="1200" b="1" dirty="0" err="1" smtClean="0">
                  <a:solidFill>
                    <a:schemeClr val="bg1"/>
                  </a:solidFill>
                </a:rPr>
                <a:t>eras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162268" y="2315523"/>
              <a:ext cx="72276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WT </a:t>
              </a:r>
            </a:p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control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469242" y="2315523"/>
              <a:ext cx="7286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H1299 </a:t>
              </a:r>
            </a:p>
            <a:p>
              <a:pPr algn="ctr"/>
              <a:r>
                <a:rPr lang="en-US" sz="1200" b="1" dirty="0" err="1" smtClean="0">
                  <a:solidFill>
                    <a:schemeClr val="bg1"/>
                  </a:solidFill>
                </a:rPr>
                <a:t>eras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847234" y="2323125"/>
              <a:ext cx="7286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H1299 </a:t>
              </a:r>
            </a:p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control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cxnSp>
          <p:nvCxnSpPr>
            <p:cNvPr id="13" name="Straight Connector 12"/>
            <p:cNvCxnSpPr/>
            <p:nvPr/>
          </p:nvCxnSpPr>
          <p:spPr>
            <a:xfrm>
              <a:off x="1040130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1662306" y="276987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2329659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3006043" y="278479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" name="Group 16"/>
          <p:cNvGrpSpPr/>
          <p:nvPr/>
        </p:nvGrpSpPr>
        <p:grpSpPr>
          <a:xfrm>
            <a:off x="4657056" y="2959022"/>
            <a:ext cx="2725014" cy="469267"/>
            <a:chOff x="847234" y="2315523"/>
            <a:chExt cx="2725014" cy="469267"/>
          </a:xfrm>
        </p:grpSpPr>
        <p:sp>
          <p:nvSpPr>
            <p:cNvPr id="18" name="TextBox 17"/>
            <p:cNvSpPr txBox="1"/>
            <p:nvPr/>
          </p:nvSpPr>
          <p:spPr>
            <a:xfrm>
              <a:off x="2795855" y="2323125"/>
              <a:ext cx="7763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WT </a:t>
              </a:r>
            </a:p>
            <a:p>
              <a:pPr algn="ctr"/>
              <a:r>
                <a:rPr lang="en-US" sz="1200" b="1" dirty="0" err="1" smtClean="0">
                  <a:solidFill>
                    <a:schemeClr val="bg1"/>
                  </a:solidFill>
                </a:rPr>
                <a:t>eras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162268" y="2315523"/>
              <a:ext cx="72276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WT </a:t>
              </a:r>
            </a:p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control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469242" y="2315523"/>
              <a:ext cx="7286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H1299 </a:t>
              </a:r>
            </a:p>
            <a:p>
              <a:pPr algn="ctr"/>
              <a:r>
                <a:rPr lang="en-US" sz="1200" b="1" dirty="0" err="1" smtClean="0">
                  <a:solidFill>
                    <a:schemeClr val="bg1"/>
                  </a:solidFill>
                </a:rPr>
                <a:t>eras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847234" y="2323125"/>
              <a:ext cx="7286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H1299 </a:t>
              </a:r>
            </a:p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control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cxnSp>
          <p:nvCxnSpPr>
            <p:cNvPr id="22" name="Straight Connector 21"/>
            <p:cNvCxnSpPr/>
            <p:nvPr/>
          </p:nvCxnSpPr>
          <p:spPr>
            <a:xfrm>
              <a:off x="1040130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>
              <a:off x="1662306" y="276987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2329659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3006043" y="278479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" name="Group 25"/>
          <p:cNvGrpSpPr/>
          <p:nvPr/>
        </p:nvGrpSpPr>
        <p:grpSpPr>
          <a:xfrm>
            <a:off x="8825525" y="2703980"/>
            <a:ext cx="2850744" cy="469267"/>
            <a:chOff x="847234" y="2315523"/>
            <a:chExt cx="2850744" cy="469267"/>
          </a:xfrm>
        </p:grpSpPr>
        <p:sp>
          <p:nvSpPr>
            <p:cNvPr id="27" name="TextBox 26"/>
            <p:cNvSpPr txBox="1"/>
            <p:nvPr/>
          </p:nvSpPr>
          <p:spPr>
            <a:xfrm>
              <a:off x="2921585" y="2323125"/>
              <a:ext cx="7763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WT </a:t>
              </a:r>
            </a:p>
            <a:p>
              <a:pPr algn="ctr"/>
              <a:r>
                <a:rPr lang="en-US" sz="1200" b="1" dirty="0" err="1" smtClean="0">
                  <a:solidFill>
                    <a:schemeClr val="bg1"/>
                  </a:solidFill>
                </a:rPr>
                <a:t>eras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207988" y="2315523"/>
              <a:ext cx="72276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WT </a:t>
              </a:r>
            </a:p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control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503532" y="2315523"/>
              <a:ext cx="7286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H1299 </a:t>
              </a:r>
            </a:p>
            <a:p>
              <a:pPr algn="ctr"/>
              <a:r>
                <a:rPr lang="en-US" sz="1200" b="1" dirty="0" err="1" smtClean="0">
                  <a:solidFill>
                    <a:schemeClr val="bg1"/>
                  </a:solidFill>
                </a:rPr>
                <a:t>eras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847234" y="2323125"/>
              <a:ext cx="7286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H1299 </a:t>
              </a:r>
            </a:p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control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cxnSp>
          <p:nvCxnSpPr>
            <p:cNvPr id="31" name="Straight Connector 30"/>
            <p:cNvCxnSpPr/>
            <p:nvPr/>
          </p:nvCxnSpPr>
          <p:spPr>
            <a:xfrm>
              <a:off x="1040130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/>
          </p:nvCxnSpPr>
          <p:spPr>
            <a:xfrm>
              <a:off x="1696596" y="276987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/>
          </p:nvCxnSpPr>
          <p:spPr>
            <a:xfrm>
              <a:off x="2386809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3074623" y="278479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6403252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l="19879" t="18254" r="8975" b="12302"/>
          <a:stretch/>
        </p:blipFill>
        <p:spPr>
          <a:xfrm>
            <a:off x="44451" y="1867460"/>
            <a:ext cx="3943350" cy="289952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03615" y="1490811"/>
            <a:ext cx="27989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Transferrin </a:t>
            </a:r>
            <a:r>
              <a:rPr lang="en-US" b="1" dirty="0" smtClean="0"/>
              <a:t>receptor (TFRC)</a:t>
            </a:r>
            <a:endParaRPr lang="en-US" b="1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/>
          <a:srcRect l="13519" t="17907" r="11672" b="11261"/>
          <a:stretch/>
        </p:blipFill>
        <p:spPr>
          <a:xfrm>
            <a:off x="4060023" y="1860143"/>
            <a:ext cx="4075276" cy="290684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/>
          <a:srcRect l="8417" t="18602" r="17822" b="8135"/>
          <a:stretch/>
        </p:blipFill>
        <p:spPr>
          <a:xfrm>
            <a:off x="8280739" y="1878270"/>
            <a:ext cx="3860745" cy="2888714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4657056" y="1490811"/>
            <a:ext cx="27989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H-ferritin (FTH1)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8638352" y="1508938"/>
            <a:ext cx="27989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GAPDH</a:t>
            </a:r>
            <a:endParaRPr lang="en-US" b="1" dirty="0"/>
          </a:p>
        </p:txBody>
      </p:sp>
      <p:grpSp>
        <p:nvGrpSpPr>
          <p:cNvPr id="19" name="Group 18"/>
          <p:cNvGrpSpPr/>
          <p:nvPr/>
        </p:nvGrpSpPr>
        <p:grpSpPr>
          <a:xfrm>
            <a:off x="778654" y="2304395"/>
            <a:ext cx="2435519" cy="480395"/>
            <a:chOff x="847234" y="2304395"/>
            <a:chExt cx="2435519" cy="480395"/>
          </a:xfrm>
        </p:grpSpPr>
        <p:sp>
          <p:nvSpPr>
            <p:cNvPr id="10" name="TextBox 9"/>
            <p:cNvSpPr txBox="1"/>
            <p:nvPr/>
          </p:nvSpPr>
          <p:spPr>
            <a:xfrm>
              <a:off x="2506360" y="2304395"/>
              <a:ext cx="7763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48Q </a:t>
              </a:r>
              <a:endParaRPr lang="en-US" sz="1200" b="1" dirty="0" smtClean="0">
                <a:solidFill>
                  <a:schemeClr val="bg1"/>
                </a:solidFill>
              </a:endParaRPr>
            </a:p>
            <a:p>
              <a:pPr algn="ctr"/>
              <a:r>
                <a:rPr lang="en-US" sz="1200" b="1" dirty="0" err="1" smtClean="0">
                  <a:solidFill>
                    <a:schemeClr val="bg1"/>
                  </a:solidFill>
                </a:rPr>
                <a:t>eras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995003" y="2315523"/>
              <a:ext cx="72276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48Q </a:t>
              </a:r>
              <a:endParaRPr lang="en-US" sz="1200" b="1" dirty="0" smtClean="0">
                <a:solidFill>
                  <a:schemeClr val="bg1"/>
                </a:solidFill>
              </a:endParaRPr>
            </a:p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control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413487" y="2315523"/>
              <a:ext cx="7286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73H </a:t>
              </a:r>
              <a:endParaRPr lang="en-US" sz="1200" b="1" dirty="0" smtClean="0">
                <a:solidFill>
                  <a:schemeClr val="bg1"/>
                </a:solidFill>
              </a:endParaRPr>
            </a:p>
            <a:p>
              <a:pPr algn="ctr"/>
              <a:r>
                <a:rPr lang="en-US" sz="1200" b="1" dirty="0" err="1" smtClean="0">
                  <a:solidFill>
                    <a:schemeClr val="bg1"/>
                  </a:solidFill>
                </a:rPr>
                <a:t>eras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847234" y="2323125"/>
              <a:ext cx="7286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73H </a:t>
              </a:r>
              <a:endParaRPr lang="en-US" sz="1200" b="1" dirty="0" smtClean="0">
                <a:solidFill>
                  <a:schemeClr val="bg1"/>
                </a:solidFill>
              </a:endParaRPr>
            </a:p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control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cxnSp>
          <p:nvCxnSpPr>
            <p:cNvPr id="15" name="Straight Connector 14"/>
            <p:cNvCxnSpPr/>
            <p:nvPr/>
          </p:nvCxnSpPr>
          <p:spPr>
            <a:xfrm>
              <a:off x="1040130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1606551" y="276987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2151243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2671944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" name="Group 19"/>
          <p:cNvGrpSpPr/>
          <p:nvPr/>
        </p:nvGrpSpPr>
        <p:grpSpPr>
          <a:xfrm>
            <a:off x="5031924" y="2968272"/>
            <a:ext cx="2526959" cy="480395"/>
            <a:chOff x="847234" y="2304395"/>
            <a:chExt cx="2526959" cy="480395"/>
          </a:xfrm>
        </p:grpSpPr>
        <p:sp>
          <p:nvSpPr>
            <p:cNvPr id="21" name="TextBox 20"/>
            <p:cNvSpPr txBox="1"/>
            <p:nvPr/>
          </p:nvSpPr>
          <p:spPr>
            <a:xfrm>
              <a:off x="2597800" y="2304395"/>
              <a:ext cx="7763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48Q </a:t>
              </a:r>
              <a:endParaRPr lang="en-US" sz="1200" b="1" dirty="0" smtClean="0">
                <a:solidFill>
                  <a:schemeClr val="bg1"/>
                </a:solidFill>
              </a:endParaRPr>
            </a:p>
            <a:p>
              <a:pPr algn="ctr"/>
              <a:r>
                <a:rPr lang="en-US" sz="1200" b="1" dirty="0" err="1" smtClean="0">
                  <a:solidFill>
                    <a:schemeClr val="bg1"/>
                  </a:solidFill>
                </a:rPr>
                <a:t>eras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017863" y="2315523"/>
              <a:ext cx="72276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48Q </a:t>
              </a:r>
              <a:endParaRPr lang="en-US" sz="1200" b="1" dirty="0" smtClean="0">
                <a:solidFill>
                  <a:schemeClr val="bg1"/>
                </a:solidFill>
              </a:endParaRPr>
            </a:p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control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413487" y="2315523"/>
              <a:ext cx="7286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73H </a:t>
              </a:r>
              <a:endParaRPr lang="en-US" sz="1200" b="1" dirty="0" smtClean="0">
                <a:solidFill>
                  <a:schemeClr val="bg1"/>
                </a:solidFill>
              </a:endParaRPr>
            </a:p>
            <a:p>
              <a:pPr algn="ctr"/>
              <a:r>
                <a:rPr lang="en-US" sz="1200" b="1" dirty="0" err="1" smtClean="0">
                  <a:solidFill>
                    <a:schemeClr val="bg1"/>
                  </a:solidFill>
                </a:rPr>
                <a:t>eras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847234" y="2323125"/>
              <a:ext cx="7286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73H </a:t>
              </a:r>
              <a:endParaRPr lang="en-US" sz="1200" b="1" dirty="0" smtClean="0">
                <a:solidFill>
                  <a:schemeClr val="bg1"/>
                </a:solidFill>
              </a:endParaRPr>
            </a:p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control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cxnSp>
          <p:nvCxnSpPr>
            <p:cNvPr id="25" name="Straight Connector 24"/>
            <p:cNvCxnSpPr/>
            <p:nvPr/>
          </p:nvCxnSpPr>
          <p:spPr>
            <a:xfrm>
              <a:off x="1040130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>
              <a:off x="1606551" y="276987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>
              <a:off x="2196963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/>
          </p:nvCxnSpPr>
          <p:spPr>
            <a:xfrm>
              <a:off x="2763384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9" name="Group 28"/>
          <p:cNvGrpSpPr/>
          <p:nvPr/>
        </p:nvGrpSpPr>
        <p:grpSpPr>
          <a:xfrm>
            <a:off x="9004781" y="3082429"/>
            <a:ext cx="2412659" cy="480395"/>
            <a:chOff x="847234" y="2304395"/>
            <a:chExt cx="2412659" cy="480395"/>
          </a:xfrm>
        </p:grpSpPr>
        <p:sp>
          <p:nvSpPr>
            <p:cNvPr id="30" name="TextBox 29"/>
            <p:cNvSpPr txBox="1"/>
            <p:nvPr/>
          </p:nvSpPr>
          <p:spPr>
            <a:xfrm>
              <a:off x="2483500" y="2304395"/>
              <a:ext cx="7763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48Q </a:t>
              </a:r>
              <a:endParaRPr lang="en-US" sz="1200" b="1" dirty="0" smtClean="0">
                <a:solidFill>
                  <a:schemeClr val="bg1"/>
                </a:solidFill>
              </a:endParaRPr>
            </a:p>
            <a:p>
              <a:pPr algn="ctr"/>
              <a:r>
                <a:rPr lang="en-US" sz="1200" b="1" dirty="0" err="1" smtClean="0">
                  <a:solidFill>
                    <a:schemeClr val="bg1"/>
                  </a:solidFill>
                </a:rPr>
                <a:t>eras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972143" y="2315523"/>
              <a:ext cx="72276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48Q </a:t>
              </a:r>
              <a:endParaRPr lang="en-US" sz="1200" b="1" dirty="0" smtClean="0">
                <a:solidFill>
                  <a:schemeClr val="bg1"/>
                </a:solidFill>
              </a:endParaRPr>
            </a:p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control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413487" y="2315523"/>
              <a:ext cx="7286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73H </a:t>
              </a:r>
              <a:endParaRPr lang="en-US" sz="1200" b="1" dirty="0" smtClean="0">
                <a:solidFill>
                  <a:schemeClr val="bg1"/>
                </a:solidFill>
              </a:endParaRPr>
            </a:p>
            <a:p>
              <a:pPr algn="ctr"/>
              <a:r>
                <a:rPr lang="en-US" sz="1200" b="1" dirty="0" err="1" smtClean="0">
                  <a:solidFill>
                    <a:schemeClr val="bg1"/>
                  </a:solidFill>
                </a:rPr>
                <a:t>eras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847234" y="2323125"/>
              <a:ext cx="7286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73H </a:t>
              </a:r>
              <a:endParaRPr lang="en-US" sz="1200" b="1" dirty="0" smtClean="0">
                <a:solidFill>
                  <a:schemeClr val="bg1"/>
                </a:solidFill>
              </a:endParaRPr>
            </a:p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control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cxnSp>
          <p:nvCxnSpPr>
            <p:cNvPr id="34" name="Straight Connector 33"/>
            <p:cNvCxnSpPr/>
            <p:nvPr/>
          </p:nvCxnSpPr>
          <p:spPr>
            <a:xfrm>
              <a:off x="1040130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>
              <a:off x="1606551" y="276987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>
              <a:off x="2151243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>
              <a:off x="2671944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2996641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19940" r="17286" b="27930"/>
          <a:stretch/>
        </p:blipFill>
        <p:spPr>
          <a:xfrm>
            <a:off x="80010" y="1801685"/>
            <a:ext cx="3943350" cy="341039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l="12377" t="6680" r="24092" b="24885"/>
          <a:stretch/>
        </p:blipFill>
        <p:spPr>
          <a:xfrm>
            <a:off x="4105600" y="1801684"/>
            <a:ext cx="4183380" cy="339471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/>
          <a:srcRect l="13483" t="11080" r="25362" b="16988"/>
          <a:stretch/>
        </p:blipFill>
        <p:spPr>
          <a:xfrm>
            <a:off x="8371220" y="1801684"/>
            <a:ext cx="3831242" cy="339471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03615" y="1490811"/>
            <a:ext cx="27989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Transferrin </a:t>
            </a:r>
            <a:r>
              <a:rPr lang="en-US" b="1" dirty="0" smtClean="0"/>
              <a:t>receptor (TFRC)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4657056" y="1490811"/>
            <a:ext cx="27989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H-ferritin (FTH1)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8638352" y="1508938"/>
            <a:ext cx="27989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GAPDH</a:t>
            </a:r>
            <a:endParaRPr lang="en-US" b="1" dirty="0"/>
          </a:p>
        </p:txBody>
      </p:sp>
      <p:grpSp>
        <p:nvGrpSpPr>
          <p:cNvPr id="8" name="Group 7"/>
          <p:cNvGrpSpPr/>
          <p:nvPr/>
        </p:nvGrpSpPr>
        <p:grpSpPr>
          <a:xfrm>
            <a:off x="600234" y="2627757"/>
            <a:ext cx="2725014" cy="469267"/>
            <a:chOff x="847234" y="2315523"/>
            <a:chExt cx="2725014" cy="469267"/>
          </a:xfrm>
        </p:grpSpPr>
        <p:sp>
          <p:nvSpPr>
            <p:cNvPr id="9" name="TextBox 8"/>
            <p:cNvSpPr txBox="1"/>
            <p:nvPr/>
          </p:nvSpPr>
          <p:spPr>
            <a:xfrm>
              <a:off x="2795855" y="2323125"/>
              <a:ext cx="7763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175H </a:t>
              </a:r>
            </a:p>
            <a:p>
              <a:pPr algn="ctr"/>
              <a:r>
                <a:rPr lang="en-US" sz="1200" b="1" dirty="0" err="1" smtClean="0">
                  <a:solidFill>
                    <a:schemeClr val="bg1"/>
                  </a:solidFill>
                </a:rPr>
                <a:t>eras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162268" y="2315523"/>
              <a:ext cx="72276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175H </a:t>
              </a:r>
            </a:p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control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469242" y="2315523"/>
              <a:ext cx="7286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82W </a:t>
              </a:r>
            </a:p>
            <a:p>
              <a:pPr algn="ctr"/>
              <a:r>
                <a:rPr lang="en-US" sz="1200" b="1" dirty="0" err="1" smtClean="0">
                  <a:solidFill>
                    <a:schemeClr val="bg1"/>
                  </a:solidFill>
                </a:rPr>
                <a:t>eras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847234" y="2323125"/>
              <a:ext cx="7286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82W </a:t>
              </a:r>
            </a:p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control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cxnSp>
          <p:nvCxnSpPr>
            <p:cNvPr id="13" name="Straight Connector 12"/>
            <p:cNvCxnSpPr/>
            <p:nvPr/>
          </p:nvCxnSpPr>
          <p:spPr>
            <a:xfrm>
              <a:off x="1040130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1662306" y="276987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2329659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3006043" y="278479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" name="Group 16"/>
          <p:cNvGrpSpPr/>
          <p:nvPr/>
        </p:nvGrpSpPr>
        <p:grpSpPr>
          <a:xfrm>
            <a:off x="4834783" y="3750314"/>
            <a:ext cx="2725014" cy="469267"/>
            <a:chOff x="847234" y="2315523"/>
            <a:chExt cx="2725014" cy="469267"/>
          </a:xfrm>
        </p:grpSpPr>
        <p:sp>
          <p:nvSpPr>
            <p:cNvPr id="18" name="TextBox 17"/>
            <p:cNvSpPr txBox="1"/>
            <p:nvPr/>
          </p:nvSpPr>
          <p:spPr>
            <a:xfrm>
              <a:off x="2795855" y="2323125"/>
              <a:ext cx="7763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175H </a:t>
              </a:r>
            </a:p>
            <a:p>
              <a:pPr algn="ctr"/>
              <a:r>
                <a:rPr lang="en-US" sz="1200" b="1" dirty="0" err="1" smtClean="0">
                  <a:solidFill>
                    <a:schemeClr val="bg1"/>
                  </a:solidFill>
                </a:rPr>
                <a:t>eras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162268" y="2315523"/>
              <a:ext cx="72276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175H </a:t>
              </a:r>
            </a:p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control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469242" y="2315523"/>
              <a:ext cx="7286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82W </a:t>
              </a:r>
            </a:p>
            <a:p>
              <a:pPr algn="ctr"/>
              <a:r>
                <a:rPr lang="en-US" sz="1200" b="1" dirty="0" err="1" smtClean="0">
                  <a:solidFill>
                    <a:schemeClr val="bg1"/>
                  </a:solidFill>
                </a:rPr>
                <a:t>eras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847234" y="2323125"/>
              <a:ext cx="7286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82W </a:t>
              </a:r>
            </a:p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control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cxnSp>
          <p:nvCxnSpPr>
            <p:cNvPr id="22" name="Straight Connector 21"/>
            <p:cNvCxnSpPr/>
            <p:nvPr/>
          </p:nvCxnSpPr>
          <p:spPr>
            <a:xfrm>
              <a:off x="1040130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>
              <a:off x="1662306" y="276987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2329659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3006043" y="278479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" name="Group 25"/>
          <p:cNvGrpSpPr/>
          <p:nvPr/>
        </p:nvGrpSpPr>
        <p:grpSpPr>
          <a:xfrm>
            <a:off x="9002391" y="2913453"/>
            <a:ext cx="2725014" cy="469267"/>
            <a:chOff x="847234" y="2315523"/>
            <a:chExt cx="2725014" cy="469267"/>
          </a:xfrm>
        </p:grpSpPr>
        <p:sp>
          <p:nvSpPr>
            <p:cNvPr id="27" name="TextBox 26"/>
            <p:cNvSpPr txBox="1"/>
            <p:nvPr/>
          </p:nvSpPr>
          <p:spPr>
            <a:xfrm>
              <a:off x="2795855" y="2323125"/>
              <a:ext cx="7763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175H </a:t>
              </a:r>
            </a:p>
            <a:p>
              <a:pPr algn="ctr"/>
              <a:r>
                <a:rPr lang="en-US" sz="1200" b="1" dirty="0" err="1" smtClean="0">
                  <a:solidFill>
                    <a:schemeClr val="bg1"/>
                  </a:solidFill>
                </a:rPr>
                <a:t>eras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162268" y="2315523"/>
              <a:ext cx="72276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175H </a:t>
              </a:r>
            </a:p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control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469242" y="2315523"/>
              <a:ext cx="7286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82W </a:t>
              </a:r>
            </a:p>
            <a:p>
              <a:pPr algn="ctr"/>
              <a:r>
                <a:rPr lang="en-US" sz="1200" b="1" dirty="0" err="1" smtClean="0">
                  <a:solidFill>
                    <a:schemeClr val="bg1"/>
                  </a:solidFill>
                </a:rPr>
                <a:t>eras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847234" y="2323125"/>
              <a:ext cx="7286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82W </a:t>
              </a:r>
            </a:p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control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cxnSp>
          <p:nvCxnSpPr>
            <p:cNvPr id="31" name="Straight Connector 30"/>
            <p:cNvCxnSpPr/>
            <p:nvPr/>
          </p:nvCxnSpPr>
          <p:spPr>
            <a:xfrm>
              <a:off x="1040130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/>
          </p:nvCxnSpPr>
          <p:spPr>
            <a:xfrm>
              <a:off x="1662306" y="276987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/>
          </p:nvCxnSpPr>
          <p:spPr>
            <a:xfrm>
              <a:off x="2329659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3006043" y="278479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9900448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22547" t="9304" r="15307" b="14680"/>
          <a:stretch/>
        </p:blipFill>
        <p:spPr>
          <a:xfrm>
            <a:off x="133815" y="1851100"/>
            <a:ext cx="3713356" cy="315200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l="17859" t="12431" r="14012" b="14335"/>
          <a:stretch/>
        </p:blipFill>
        <p:spPr>
          <a:xfrm>
            <a:off x="3978895" y="1862249"/>
            <a:ext cx="3956045" cy="315544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/>
          <a:srcRect l="16281" t="19505" r="18507" b="11882"/>
          <a:stretch/>
        </p:blipFill>
        <p:spPr>
          <a:xfrm>
            <a:off x="8078022" y="1851099"/>
            <a:ext cx="3898388" cy="316659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03615" y="1490811"/>
            <a:ext cx="27989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Transferrin </a:t>
            </a:r>
            <a:r>
              <a:rPr lang="en-US" b="1" dirty="0" smtClean="0"/>
              <a:t>receptor (TFRC)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4657056" y="1490811"/>
            <a:ext cx="27989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H-ferritin (FTH1)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8638352" y="1508938"/>
            <a:ext cx="27989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GAPDH</a:t>
            </a:r>
            <a:endParaRPr lang="en-US" b="1" dirty="0"/>
          </a:p>
        </p:txBody>
      </p:sp>
      <p:grpSp>
        <p:nvGrpSpPr>
          <p:cNvPr id="8" name="Group 7"/>
          <p:cNvGrpSpPr/>
          <p:nvPr/>
        </p:nvGrpSpPr>
        <p:grpSpPr>
          <a:xfrm>
            <a:off x="540586" y="2727724"/>
            <a:ext cx="2725014" cy="469267"/>
            <a:chOff x="847234" y="2315523"/>
            <a:chExt cx="2725014" cy="469267"/>
          </a:xfrm>
        </p:grpSpPr>
        <p:sp>
          <p:nvSpPr>
            <p:cNvPr id="9" name="TextBox 8"/>
            <p:cNvSpPr txBox="1"/>
            <p:nvPr/>
          </p:nvSpPr>
          <p:spPr>
            <a:xfrm>
              <a:off x="2795855" y="2323125"/>
              <a:ext cx="7763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49H </a:t>
              </a:r>
            </a:p>
            <a:p>
              <a:pPr algn="ctr"/>
              <a:r>
                <a:rPr lang="en-US" sz="1200" b="1" dirty="0" err="1" smtClean="0">
                  <a:solidFill>
                    <a:schemeClr val="bg1"/>
                  </a:solidFill>
                </a:rPr>
                <a:t>eras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162268" y="2315523"/>
              <a:ext cx="72276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49S </a:t>
              </a:r>
            </a:p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control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469242" y="2315523"/>
              <a:ext cx="7286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45S </a:t>
              </a:r>
            </a:p>
            <a:p>
              <a:pPr algn="ctr"/>
              <a:r>
                <a:rPr lang="en-US" sz="1200" b="1" dirty="0" err="1" smtClean="0">
                  <a:solidFill>
                    <a:schemeClr val="bg1"/>
                  </a:solidFill>
                </a:rPr>
                <a:t>eras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847234" y="2323125"/>
              <a:ext cx="7286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45S </a:t>
              </a:r>
            </a:p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control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cxnSp>
          <p:nvCxnSpPr>
            <p:cNvPr id="13" name="Straight Connector 12"/>
            <p:cNvCxnSpPr/>
            <p:nvPr/>
          </p:nvCxnSpPr>
          <p:spPr>
            <a:xfrm>
              <a:off x="1040130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1662306" y="276987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2329659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3006043" y="278479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" name="Group 16"/>
          <p:cNvGrpSpPr/>
          <p:nvPr/>
        </p:nvGrpSpPr>
        <p:grpSpPr>
          <a:xfrm>
            <a:off x="4495272" y="3199763"/>
            <a:ext cx="2725014" cy="469267"/>
            <a:chOff x="847234" y="2315523"/>
            <a:chExt cx="2725014" cy="469267"/>
          </a:xfrm>
        </p:grpSpPr>
        <p:sp>
          <p:nvSpPr>
            <p:cNvPr id="18" name="TextBox 17"/>
            <p:cNvSpPr txBox="1"/>
            <p:nvPr/>
          </p:nvSpPr>
          <p:spPr>
            <a:xfrm>
              <a:off x="2795855" y="2323125"/>
              <a:ext cx="7763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49H </a:t>
              </a:r>
            </a:p>
            <a:p>
              <a:pPr algn="ctr"/>
              <a:r>
                <a:rPr lang="en-US" sz="1200" b="1" dirty="0" err="1" smtClean="0">
                  <a:solidFill>
                    <a:schemeClr val="bg1"/>
                  </a:solidFill>
                </a:rPr>
                <a:t>eras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162268" y="2315523"/>
              <a:ext cx="72276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49S </a:t>
              </a:r>
            </a:p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control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469242" y="2315523"/>
              <a:ext cx="7286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45S </a:t>
              </a:r>
            </a:p>
            <a:p>
              <a:pPr algn="ctr"/>
              <a:r>
                <a:rPr lang="en-US" sz="1200" b="1" dirty="0" err="1" smtClean="0">
                  <a:solidFill>
                    <a:schemeClr val="bg1"/>
                  </a:solidFill>
                </a:rPr>
                <a:t>eras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847234" y="2323125"/>
              <a:ext cx="7286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45S </a:t>
              </a:r>
            </a:p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control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cxnSp>
          <p:nvCxnSpPr>
            <p:cNvPr id="22" name="Straight Connector 21"/>
            <p:cNvCxnSpPr/>
            <p:nvPr/>
          </p:nvCxnSpPr>
          <p:spPr>
            <a:xfrm>
              <a:off x="1040130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>
              <a:off x="1662306" y="276987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2329659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3006043" y="278479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" name="Group 25"/>
          <p:cNvGrpSpPr/>
          <p:nvPr/>
        </p:nvGrpSpPr>
        <p:grpSpPr>
          <a:xfrm>
            <a:off x="8660654" y="3084241"/>
            <a:ext cx="2725014" cy="469267"/>
            <a:chOff x="847234" y="2315523"/>
            <a:chExt cx="2725014" cy="469267"/>
          </a:xfrm>
        </p:grpSpPr>
        <p:sp>
          <p:nvSpPr>
            <p:cNvPr id="27" name="TextBox 26"/>
            <p:cNvSpPr txBox="1"/>
            <p:nvPr/>
          </p:nvSpPr>
          <p:spPr>
            <a:xfrm>
              <a:off x="2795855" y="2323125"/>
              <a:ext cx="7763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49H </a:t>
              </a:r>
            </a:p>
            <a:p>
              <a:pPr algn="ctr"/>
              <a:r>
                <a:rPr lang="en-US" sz="1200" b="1" dirty="0" err="1" smtClean="0">
                  <a:solidFill>
                    <a:schemeClr val="bg1"/>
                  </a:solidFill>
                </a:rPr>
                <a:t>eras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162268" y="2315523"/>
              <a:ext cx="72276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49S </a:t>
              </a:r>
            </a:p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control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469242" y="2315523"/>
              <a:ext cx="7286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45S </a:t>
              </a:r>
            </a:p>
            <a:p>
              <a:pPr algn="ctr"/>
              <a:r>
                <a:rPr lang="en-US" sz="1200" b="1" dirty="0" err="1" smtClean="0">
                  <a:solidFill>
                    <a:schemeClr val="bg1"/>
                  </a:solidFill>
                </a:rPr>
                <a:t>eras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847234" y="2323125"/>
              <a:ext cx="7286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245S </a:t>
              </a:r>
            </a:p>
            <a:p>
              <a:pPr algn="ctr"/>
              <a:r>
                <a:rPr lang="en-US" sz="1200" b="1" dirty="0" smtClean="0">
                  <a:solidFill>
                    <a:schemeClr val="bg1"/>
                  </a:solidFill>
                </a:rPr>
                <a:t>control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cxnSp>
          <p:nvCxnSpPr>
            <p:cNvPr id="31" name="Straight Connector 30"/>
            <p:cNvCxnSpPr/>
            <p:nvPr/>
          </p:nvCxnSpPr>
          <p:spPr>
            <a:xfrm>
              <a:off x="1040130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/>
          </p:nvCxnSpPr>
          <p:spPr>
            <a:xfrm>
              <a:off x="1662306" y="276987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/>
          </p:nvCxnSpPr>
          <p:spPr>
            <a:xfrm>
              <a:off x="2329659" y="276606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3006043" y="2784790"/>
              <a:ext cx="36576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8163504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93BF79B885EBB49B491F1663C226B4C" ma:contentTypeVersion="12" ma:contentTypeDescription="Create a new document." ma:contentTypeScope="" ma:versionID="07cf0b7a56b585a4ff396fb5261da5fd">
  <xsd:schema xmlns:xsd="http://www.w3.org/2001/XMLSchema" xmlns:xs="http://www.w3.org/2001/XMLSchema" xmlns:p="http://schemas.microsoft.com/office/2006/metadata/properties" xmlns:ns3="ef549723-c3fb-4966-bf14-ad4d081bfc97" xmlns:ns4="3d0828cf-833c-4cd6-9d60-ea5acd20918d" targetNamespace="http://schemas.microsoft.com/office/2006/metadata/properties" ma:root="true" ma:fieldsID="e502bdc0e8564bc06803b1849965f9b2" ns3:_="" ns4:_="">
    <xsd:import namespace="ef549723-c3fb-4966-bf14-ad4d081bfc97"/>
    <xsd:import namespace="3d0828cf-833c-4cd6-9d60-ea5acd20918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DateTaken" minOccurs="0"/>
                <xsd:element ref="ns3:MediaServiceOCR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f549723-c3fb-4966-bf14-ad4d081bfc9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MediaServiceAutoTags" ma:description="" ma:internalName="MediaServiceAutoTags" ma:readOnly="true">
      <xsd:simpleType>
        <xsd:restriction base="dms:Text"/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OCR" ma:index="15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d0828cf-833c-4cd6-9d60-ea5acd20918d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description="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BED59227-8D9F-42C6-B183-3E911CFE347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f549723-c3fb-4966-bf14-ad4d081bfc97"/>
    <ds:schemaRef ds:uri="3d0828cf-833c-4cd6-9d60-ea5acd20918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03330008-3AA1-4A61-B786-769FCCD6FFED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167917D-A405-4110-BBFB-146FD0DC4F24}">
  <ds:schemaRefs>
    <ds:schemaRef ds:uri="http://schemas.openxmlformats.org/package/2006/metadata/core-properties"/>
    <ds:schemaRef ds:uri="http://schemas.microsoft.com/office/2006/documentManagement/types"/>
    <ds:schemaRef ds:uri="http://purl.org/dc/terms/"/>
    <ds:schemaRef ds:uri="http://schemas.microsoft.com/office/infopath/2007/PartnerControls"/>
    <ds:schemaRef ds:uri="http://www.w3.org/XML/1998/namespace"/>
    <ds:schemaRef ds:uri="http://purl.org/dc/elements/1.1/"/>
    <ds:schemaRef ds:uri="3d0828cf-833c-4cd6-9d60-ea5acd20918d"/>
    <ds:schemaRef ds:uri="ef549723-c3fb-4966-bf14-ad4d081bfc97"/>
    <ds:schemaRef ds:uri="http://schemas.microsoft.com/office/2006/metadata/properties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136</Words>
  <Application>Microsoft Office PowerPoint</Application>
  <PresentationFormat>Widescreen</PresentationFormat>
  <Paragraphs>10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Oklahoma Stat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ntgomery, Mckale</dc:creator>
  <cp:lastModifiedBy>Montgomery, Mckale</cp:lastModifiedBy>
  <cp:revision>8</cp:revision>
  <dcterms:created xsi:type="dcterms:W3CDTF">2020-08-12T19:47:16Z</dcterms:created>
  <dcterms:modified xsi:type="dcterms:W3CDTF">2020-08-12T20:16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93BF79B885EBB49B491F1663C226B4C</vt:lpwstr>
  </property>
</Properties>
</file>